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907588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7465C2F-0808-47F0-8FA6-8DAA76E72114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891360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360" y="3963600"/>
            <a:ext cx="891360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2365CB1-3385-4D7A-B0A8-A885E261A71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2680" y="16002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360" y="39636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2680" y="39636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CBC0635-03B4-450E-A13D-EBF45BFAC3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28699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280" y="1600200"/>
            <a:ext cx="28699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2840" y="1600200"/>
            <a:ext cx="28699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360" y="3963600"/>
            <a:ext cx="28699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280" y="3963600"/>
            <a:ext cx="28699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2840" y="3963600"/>
            <a:ext cx="28699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17AD17D-D21C-4405-9E90-2FF339921590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360" y="1600200"/>
            <a:ext cx="891360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5E54363-D6EA-4AC4-87D7-0E371E7129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891360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4DAA0DC-28FB-4F92-98D2-58BF852BEE2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434952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2680" y="1600200"/>
            <a:ext cx="434952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6115FB2-5F97-41E6-9985-7EA91F12C73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CCABCB1-5D4E-4B8A-8BD8-F04D71DA4CF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360" y="274680"/>
            <a:ext cx="8913600" cy="529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spcBef>
                <a:spcPts val="7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5469F51-3525-4553-ADBF-9979CCEB57F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2680" y="1600200"/>
            <a:ext cx="434952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360" y="39636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3A87BBB-F679-4EB9-9105-CA674AA0B4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434952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2680" y="16002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2680" y="39636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02FB0B7-1ABB-4C7D-9C68-AC191B099A7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2680" y="16002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360" y="3963600"/>
            <a:ext cx="891360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8D552C9-C48A-46B9-B1B0-1C7364889BC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360" y="1600200"/>
            <a:ext cx="891360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6356160"/>
            <a:ext cx="2309760" cy="36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  <a:defRPr b="0" lang="de-DE" sz="1800" spc="-1" strike="noStrike">
                <a:solidFill>
                  <a:srgbClr val="000000"/>
                </a:solidFill>
                <a:latin typeface="Arial"/>
                <a:ea typeface="Segoe U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  <a:ea typeface="Segoe UI"/>
              </a:rPr>
              <a:t>&lt;date/time&gt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"/>
          <p:cNvSpPr/>
          <p:nvPr/>
        </p:nvSpPr>
        <p:spPr>
          <a:xfrm>
            <a:off x="3384720" y="6356520"/>
            <a:ext cx="313668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sldNum" idx="2"/>
          </p:nvPr>
        </p:nvSpPr>
        <p:spPr>
          <a:xfrm>
            <a:off x="7099200" y="6356160"/>
            <a:ext cx="2309760" cy="36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  <a:defRPr b="0" lang="de-DE" sz="1800" spc="-1" strike="noStrike">
                <a:solidFill>
                  <a:srgbClr val="000000"/>
                </a:solidFill>
                <a:latin typeface="Arial"/>
                <a:ea typeface="Segoe U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fld id="{ADAD6B32-9594-428A-8961-F22942DF2C6E}" type="slidenum">
              <a:rPr b="0" lang="de-DE" sz="1800" spc="-1" strike="noStrike">
                <a:solidFill>
                  <a:srgbClr val="000000"/>
                </a:solidFill>
                <a:latin typeface="Arial"/>
                <a:ea typeface="Segoe UI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00160" y="0"/>
            <a:ext cx="7630920" cy="6595920"/>
            <a:chOff x="200160" y="0"/>
            <a:chExt cx="7630920" cy="6595920"/>
          </a:xfrm>
        </p:grpSpPr>
        <p:sp>
          <p:nvSpPr>
            <p:cNvPr id="42" name=""/>
            <p:cNvSpPr/>
            <p:nvPr/>
          </p:nvSpPr>
          <p:spPr>
            <a:xfrm>
              <a:off x="200160" y="0"/>
              <a:ext cx="7630920" cy="6595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3" name="" descr=""/>
            <p:cNvPicPr/>
            <p:nvPr/>
          </p:nvPicPr>
          <p:blipFill>
            <a:blip r:embed="rId1"/>
            <a:stretch/>
          </p:blipFill>
          <p:spPr>
            <a:xfrm>
              <a:off x="250920" y="345960"/>
              <a:ext cx="4222800" cy="3340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" descr=""/>
            <p:cNvPicPr/>
            <p:nvPr/>
          </p:nvPicPr>
          <p:blipFill>
            <a:blip r:embed="rId2"/>
            <a:stretch/>
          </p:blipFill>
          <p:spPr>
            <a:xfrm>
              <a:off x="3443400" y="351000"/>
              <a:ext cx="4171680" cy="3340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" descr=""/>
            <p:cNvPicPr/>
            <p:nvPr/>
          </p:nvPicPr>
          <p:blipFill>
            <a:blip r:embed="rId3"/>
            <a:stretch/>
          </p:blipFill>
          <p:spPr>
            <a:xfrm>
              <a:off x="285840" y="3213000"/>
              <a:ext cx="4172040" cy="3338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" descr=""/>
            <p:cNvPicPr/>
            <p:nvPr/>
          </p:nvPicPr>
          <p:blipFill>
            <a:blip r:embed="rId4"/>
            <a:stretch/>
          </p:blipFill>
          <p:spPr>
            <a:xfrm>
              <a:off x="3438360" y="3240000"/>
              <a:ext cx="4172040" cy="3338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"/>
            <p:cNvSpPr/>
            <p:nvPr/>
          </p:nvSpPr>
          <p:spPr>
            <a:xfrm>
              <a:off x="1848960" y="5421240"/>
              <a:ext cx="152028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gnificant predictors: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Soil (*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ovenance x Soil *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5025600" y="5421240"/>
              <a:ext cx="152028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gnificant predictors: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ovenance ***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Soil (*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4086000" y="318600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4733640" y="318600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5382720" y="318600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6049440" y="318600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4953960" y="2714760"/>
              <a:ext cx="152028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gnificant predictors: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ovenance **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1882080" y="2571840"/>
              <a:ext cx="152028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   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gnificant predictors: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ovenance ***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917280" y="404640"/>
              <a:ext cx="342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566360" y="40464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214360" y="40464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2881080" y="404640"/>
              <a:ext cx="342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4085280" y="333360"/>
              <a:ext cx="35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4733640" y="33336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5382360" y="333360"/>
              <a:ext cx="35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6049440" y="33336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6607080" y="3141720"/>
              <a:ext cx="790560" cy="717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3-13T10:13:08Z</dcterms:created>
  <dc:creator>Buhk</dc:creator>
  <dc:description/>
  <dc:language>en-US</dc:language>
  <cp:lastModifiedBy>Nutzer</cp:lastModifiedBy>
  <dcterms:modified xsi:type="dcterms:W3CDTF">2016-02-17T08:15:39Z</dcterms:modified>
  <cp:revision>37</cp:revision>
  <dc:subject/>
  <dc:title>Folie 1</dc:title>
</cp:coreProperties>
</file>